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1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800EE-356F-703A-6E98-7F9B51257E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7B7A9C-75E3-3766-355C-50BFCA8E3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2C0C3-C865-D08E-9315-59ABFE44A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8D42E-93DC-334C-CF2D-737D13412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FDF33-B969-1FC7-D676-F9AC007A4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601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75D07-C5B4-6CDA-AF09-B7B620EA7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F1BADA-3DCF-CF8F-1199-DD459D5C8F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1BFB9B-47EE-5DE5-0E1A-96CF17819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1D55D-B268-3DF2-5A97-ADB4CE5F1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C853B-8326-2FEB-9C40-E08E70440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50230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9C8C41-3B7A-4B31-6D59-9621E846F7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C971E6-6847-EBD0-BCE9-C5DBAAF103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26422-19EE-E81F-7116-56D2069AF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14EC2-8A71-D6B3-16AC-8017BB0DF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9E1A2-C699-D3D7-53CF-5218321F2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097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2A3D5-AE3A-5AF8-20F7-8462CA1E7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8453A9-9881-A454-C31A-2C1A60191B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9817D-B352-3D54-8A4B-52D106274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428981-C160-BD60-A1A6-3929DC6ED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882D2-7284-E13A-8302-49702D623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98776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A399E-B71C-EAC8-7F54-AC4E7F7C09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91AA55-CC4C-E37F-5AB7-408E6A3D80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97ECD-B0E4-9BA3-5DC7-4B9D1584D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13FC4-F846-894B-2458-00B1C0801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2F278-4412-F18D-D31F-E98284758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58765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C61C8-4B73-0B3A-2056-9881E2634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F3867A-9957-71EA-3BCC-E4D98C8C9A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48F9CB-1E9A-3ED2-561B-4D14C3D6ED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D1C579-7F0C-59FF-2ACB-F10BA3183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3ABA16-ACE7-DC57-43A6-C059B50E8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ACEEBD-00E1-D1B1-E405-06E58C58B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897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3C99E-08F0-852A-066A-60D29A5A9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AE93F2-6B40-823A-177E-5F6DC31BE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ABC142-CED0-B298-774C-8832F3FC13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4FD5A72-6FC4-B51C-8D9E-705A78AF3E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F13A9E-9934-63D8-BFB8-93292C9AC7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A55947-8C9D-AEDE-D058-B7C07019E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0B3C03-88E3-4984-80F0-17C4952CB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754EA8-BC37-8174-8AC5-B5A950B65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8542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2E177-6BC7-17B3-D129-7BE309EDA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81169A-F2CA-F3C4-48C6-AC90B7C38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57DFBD-EFE2-5254-06D0-644F1770F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00A8F6-A622-F032-71D7-9AB6B20D4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890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8911E1-D3AB-0EF9-CAA4-F86629286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5FDEE9-D79A-E50D-F73C-0EF582481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FAE346-5F13-B289-CC7E-E4F1BA43B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7282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AFC9F-8EBD-9E5C-2BBF-8FBF58F98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2526A0-0218-6E57-6017-77A1361F7C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D38777-0323-05CA-ADFC-552BCBFB40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D30917-4FE3-0CBE-137B-C37CDCE6F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03D77-B513-5EE6-28E1-E9943FFE7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1FEA3C-7C71-DE84-9EA2-C8C50F112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00822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07775-14CB-5826-5382-71259F00B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CDC05D-EAF7-8F85-9AD5-FB723D271D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B19E0D-568E-0468-A0B1-91652314B1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4E7E2C-60B7-9A49-20AA-79DBC2F7A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A60477-17DA-DE5E-58AB-F9D45369D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2225C2-BC11-552E-023E-2E1F0B329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94707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809782-74E2-178A-1CC3-C1DECE1A0C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DF49E3-B828-2032-EBEB-B8896BD5E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BDB8E-6DF8-D4BE-A185-159437321F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147E3B-8642-49FD-8C45-128977EE873C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3835E-CEA1-DD79-F347-DF2935AE26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16B69A-21BE-E065-37EF-ABB08FF0F5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4EE61C-A740-4306-AD3E-1FE92D0E554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84800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lose-up of a dna test&#10;&#10;Description automatically generated">
            <a:extLst>
              <a:ext uri="{FF2B5EF4-FFF2-40B4-BE49-F238E27FC236}">
                <a16:creationId xmlns:a16="http://schemas.microsoft.com/office/drawing/2014/main" id="{60934DE9-D58F-5F11-02EB-8EFAFD1ADEE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54309" y="2778520"/>
            <a:ext cx="3397677" cy="2359338"/>
          </a:xfrm>
          <a:prstGeom prst="rect">
            <a:avLst/>
          </a:prstGeom>
        </p:spPr>
      </p:pic>
      <p:sp>
        <p:nvSpPr>
          <p:cNvPr id="4" name="TextBox 11">
            <a:extLst>
              <a:ext uri="{FF2B5EF4-FFF2-40B4-BE49-F238E27FC236}">
                <a16:creationId xmlns:a16="http://schemas.microsoft.com/office/drawing/2014/main" id="{4555A8AB-4711-8C87-BF0A-586C8B33E92D}"/>
              </a:ext>
            </a:extLst>
          </p:cNvPr>
          <p:cNvSpPr txBox="1"/>
          <p:nvPr/>
        </p:nvSpPr>
        <p:spPr bwMode="auto">
          <a:xfrm>
            <a:off x="280442" y="29757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600" b="1" dirty="0">
                <a:latin typeface="Arial"/>
                <a:cs typeface="Arial"/>
              </a:rPr>
              <a:t>Figure 6C</a:t>
            </a:r>
            <a:endParaRPr sz="1600" b="1" dirty="0">
              <a:latin typeface="Arial"/>
              <a:cs typeface="Arial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E6C1254-0056-4FB3-FF81-CE67B16E48DD}"/>
              </a:ext>
            </a:extLst>
          </p:cNvPr>
          <p:cNvSpPr/>
          <p:nvPr/>
        </p:nvSpPr>
        <p:spPr>
          <a:xfrm>
            <a:off x="2819633" y="3796673"/>
            <a:ext cx="866938" cy="3042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TextBox 11">
            <a:extLst>
              <a:ext uri="{FF2B5EF4-FFF2-40B4-BE49-F238E27FC236}">
                <a16:creationId xmlns:a16="http://schemas.microsoft.com/office/drawing/2014/main" id="{A70DF59F-2A8D-5D12-B6A7-0D5E4C4D1170}"/>
              </a:ext>
            </a:extLst>
          </p:cNvPr>
          <p:cNvSpPr txBox="1"/>
          <p:nvPr/>
        </p:nvSpPr>
        <p:spPr bwMode="auto">
          <a:xfrm>
            <a:off x="3483752" y="5157901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400" dirty="0">
                <a:solidFill>
                  <a:srgbClr val="FF0000"/>
                </a:solidFill>
                <a:latin typeface="Arial"/>
                <a:cs typeface="Arial"/>
              </a:rPr>
              <a:t>RIPK3</a:t>
            </a:r>
            <a:r>
              <a:rPr lang="en-US" sz="1400" dirty="0">
                <a:latin typeface="Arial"/>
                <a:cs typeface="Arial"/>
              </a:rPr>
              <a:t> (SE)</a:t>
            </a:r>
            <a:endParaRPr sz="4000" dirty="0"/>
          </a:p>
        </p:txBody>
      </p:sp>
      <p:pic>
        <p:nvPicPr>
          <p:cNvPr id="9" name="Picture 8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D22100DE-6A35-8530-B9B9-431545F7BAC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00153" y="2770739"/>
            <a:ext cx="2985283" cy="2359337"/>
          </a:xfrm>
          <a:prstGeom prst="rect">
            <a:avLst/>
          </a:prstGeom>
        </p:spPr>
      </p:pic>
      <p:sp>
        <p:nvSpPr>
          <p:cNvPr id="10" name="TextBox 11">
            <a:extLst>
              <a:ext uri="{FF2B5EF4-FFF2-40B4-BE49-F238E27FC236}">
                <a16:creationId xmlns:a16="http://schemas.microsoft.com/office/drawing/2014/main" id="{CE19ACED-8702-E855-DE17-CF14BB177CEF}"/>
              </a:ext>
            </a:extLst>
          </p:cNvPr>
          <p:cNvSpPr txBox="1"/>
          <p:nvPr/>
        </p:nvSpPr>
        <p:spPr bwMode="auto">
          <a:xfrm>
            <a:off x="8204961" y="5108473"/>
            <a:ext cx="1091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400" dirty="0">
                <a:solidFill>
                  <a:srgbClr val="FF0000"/>
                </a:solidFill>
                <a:latin typeface="Arial"/>
                <a:cs typeface="Arial"/>
              </a:rPr>
              <a:t>RIPK3</a:t>
            </a:r>
            <a:r>
              <a:rPr lang="en-US" sz="1400" dirty="0">
                <a:latin typeface="Arial"/>
                <a:cs typeface="Arial"/>
              </a:rPr>
              <a:t> (LE)</a:t>
            </a:r>
            <a:endParaRPr sz="40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5DC82D5-7B9B-7841-C461-8EEC9657DD35}"/>
              </a:ext>
            </a:extLst>
          </p:cNvPr>
          <p:cNvSpPr/>
          <p:nvPr/>
        </p:nvSpPr>
        <p:spPr>
          <a:xfrm>
            <a:off x="8293216" y="3772914"/>
            <a:ext cx="866938" cy="3042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A97C9E5-0843-F15D-D03F-06AAC94FAE0E}"/>
              </a:ext>
            </a:extLst>
          </p:cNvPr>
          <p:cNvSpPr txBox="1"/>
          <p:nvPr/>
        </p:nvSpPr>
        <p:spPr>
          <a:xfrm>
            <a:off x="2869647" y="908213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G IP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697D42F-C71E-CF00-42ED-B275448C649E}"/>
              </a:ext>
            </a:extLst>
          </p:cNvPr>
          <p:cNvSpPr txBox="1"/>
          <p:nvPr/>
        </p:nvSpPr>
        <p:spPr>
          <a:xfrm>
            <a:off x="2820667" y="2200624"/>
            <a:ext cx="1710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+   -   -      -   +   -   -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7F16CD4-B24D-A9EE-0DCA-AAC124AC6C70}"/>
              </a:ext>
            </a:extLst>
          </p:cNvPr>
          <p:cNvCxnSpPr>
            <a:cxnSpLocks/>
          </p:cNvCxnSpPr>
          <p:nvPr/>
        </p:nvCxnSpPr>
        <p:spPr>
          <a:xfrm>
            <a:off x="2852838" y="2150074"/>
            <a:ext cx="518711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9A34999-5C30-51E7-19F2-B12F38675D1C}"/>
              </a:ext>
            </a:extLst>
          </p:cNvPr>
          <p:cNvSpPr txBox="1"/>
          <p:nvPr/>
        </p:nvSpPr>
        <p:spPr>
          <a:xfrm rot="16200000">
            <a:off x="3307259" y="181468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55E1F8A-29FF-B5E2-C580-9E5A5391606C}"/>
              </a:ext>
            </a:extLst>
          </p:cNvPr>
          <p:cNvCxnSpPr>
            <a:cxnSpLocks/>
          </p:cNvCxnSpPr>
          <p:nvPr/>
        </p:nvCxnSpPr>
        <p:spPr>
          <a:xfrm>
            <a:off x="2758325" y="1154133"/>
            <a:ext cx="832497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54D6BC1D-AC6D-40CB-8CC8-8D2AC574698B}"/>
              </a:ext>
            </a:extLst>
          </p:cNvPr>
          <p:cNvSpPr txBox="1"/>
          <p:nvPr/>
        </p:nvSpPr>
        <p:spPr>
          <a:xfrm rot="16200000">
            <a:off x="2638959" y="1423393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6C2454E-1139-7D77-7090-1F68B9539DE0}"/>
              </a:ext>
            </a:extLst>
          </p:cNvPr>
          <p:cNvSpPr txBox="1"/>
          <p:nvPr/>
        </p:nvSpPr>
        <p:spPr>
          <a:xfrm>
            <a:off x="3873072" y="908213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1DA016B5-0B9B-CFF6-88BB-394CC343B7BD}"/>
              </a:ext>
            </a:extLst>
          </p:cNvPr>
          <p:cNvCxnSpPr>
            <a:cxnSpLocks/>
          </p:cNvCxnSpPr>
          <p:nvPr/>
        </p:nvCxnSpPr>
        <p:spPr>
          <a:xfrm>
            <a:off x="3712420" y="1154133"/>
            <a:ext cx="832497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557F10AE-FC66-1308-E29C-7CEF3770F424}"/>
              </a:ext>
            </a:extLst>
          </p:cNvPr>
          <p:cNvCxnSpPr>
            <a:cxnSpLocks/>
          </p:cNvCxnSpPr>
          <p:nvPr/>
        </p:nvCxnSpPr>
        <p:spPr>
          <a:xfrm>
            <a:off x="3781218" y="2150074"/>
            <a:ext cx="518711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D8FCF760-9377-5C17-00A2-694A919BA6FF}"/>
              </a:ext>
            </a:extLst>
          </p:cNvPr>
          <p:cNvSpPr txBox="1"/>
          <p:nvPr/>
        </p:nvSpPr>
        <p:spPr>
          <a:xfrm rot="16200000">
            <a:off x="4235639" y="181468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A7288D0-B5AD-E938-CC45-2778188BDA64}"/>
              </a:ext>
            </a:extLst>
          </p:cNvPr>
          <p:cNvSpPr txBox="1"/>
          <p:nvPr/>
        </p:nvSpPr>
        <p:spPr>
          <a:xfrm rot="16200000">
            <a:off x="3567339" y="1423393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508BF09-2E5B-3FBE-8C3B-C91284E63AF5}"/>
              </a:ext>
            </a:extLst>
          </p:cNvPr>
          <p:cNvSpPr txBox="1"/>
          <p:nvPr/>
        </p:nvSpPr>
        <p:spPr>
          <a:xfrm>
            <a:off x="2834192" y="2489746"/>
            <a:ext cx="1710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-   +   -      -   -   +   -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DA389B6-B240-20B3-28EA-BD0F38704102}"/>
              </a:ext>
            </a:extLst>
          </p:cNvPr>
          <p:cNvSpPr txBox="1"/>
          <p:nvPr/>
        </p:nvSpPr>
        <p:spPr>
          <a:xfrm>
            <a:off x="1958088" y="2234009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4726B84-5D4B-3E3D-44F2-6BA4F3790316}"/>
              </a:ext>
            </a:extLst>
          </p:cNvPr>
          <p:cNvSpPr txBox="1"/>
          <p:nvPr/>
        </p:nvSpPr>
        <p:spPr>
          <a:xfrm>
            <a:off x="2085174" y="2481478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PT-33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76365B5-A66E-4C76-BB86-CE565F746C94}"/>
              </a:ext>
            </a:extLst>
          </p:cNvPr>
          <p:cNvSpPr txBox="1"/>
          <p:nvPr/>
        </p:nvSpPr>
        <p:spPr>
          <a:xfrm>
            <a:off x="7491923" y="919988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G IP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3602430-7B6A-0F18-CEEE-CB43260D751B}"/>
              </a:ext>
            </a:extLst>
          </p:cNvPr>
          <p:cNvSpPr txBox="1"/>
          <p:nvPr/>
        </p:nvSpPr>
        <p:spPr>
          <a:xfrm>
            <a:off x="7442943" y="2212399"/>
            <a:ext cx="1710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+   -   -      -   +   -   -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01DC6CC7-49DB-78EE-D442-CD82557F4D9A}"/>
              </a:ext>
            </a:extLst>
          </p:cNvPr>
          <p:cNvCxnSpPr>
            <a:cxnSpLocks/>
          </p:cNvCxnSpPr>
          <p:nvPr/>
        </p:nvCxnSpPr>
        <p:spPr>
          <a:xfrm>
            <a:off x="7475114" y="2161849"/>
            <a:ext cx="518711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8E58FB27-905A-FAAF-31AF-0C981C85CE0B}"/>
              </a:ext>
            </a:extLst>
          </p:cNvPr>
          <p:cNvSpPr txBox="1"/>
          <p:nvPr/>
        </p:nvSpPr>
        <p:spPr>
          <a:xfrm rot="16200000">
            <a:off x="7929535" y="182646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EC378A16-64EF-9537-85C1-D7EAD18B547B}"/>
              </a:ext>
            </a:extLst>
          </p:cNvPr>
          <p:cNvCxnSpPr>
            <a:cxnSpLocks/>
          </p:cNvCxnSpPr>
          <p:nvPr/>
        </p:nvCxnSpPr>
        <p:spPr>
          <a:xfrm>
            <a:off x="7380601" y="1165908"/>
            <a:ext cx="832497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0B1AEE61-696F-80AF-24F3-8892D9E84FB2}"/>
              </a:ext>
            </a:extLst>
          </p:cNvPr>
          <p:cNvSpPr txBox="1"/>
          <p:nvPr/>
        </p:nvSpPr>
        <p:spPr>
          <a:xfrm rot="16200000">
            <a:off x="7261235" y="1435168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9A94779-64C4-149E-FBFF-31285197DD59}"/>
              </a:ext>
            </a:extLst>
          </p:cNvPr>
          <p:cNvSpPr txBox="1"/>
          <p:nvPr/>
        </p:nvSpPr>
        <p:spPr>
          <a:xfrm>
            <a:off x="8495348" y="919988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B1A32A2B-0601-B17C-A19D-84B0678DC718}"/>
              </a:ext>
            </a:extLst>
          </p:cNvPr>
          <p:cNvCxnSpPr>
            <a:cxnSpLocks/>
          </p:cNvCxnSpPr>
          <p:nvPr/>
        </p:nvCxnSpPr>
        <p:spPr>
          <a:xfrm>
            <a:off x="8334696" y="1165908"/>
            <a:ext cx="832497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35E15718-1395-A40A-DF7E-AA66E113E8B8}"/>
              </a:ext>
            </a:extLst>
          </p:cNvPr>
          <p:cNvCxnSpPr>
            <a:cxnSpLocks/>
          </p:cNvCxnSpPr>
          <p:nvPr/>
        </p:nvCxnSpPr>
        <p:spPr>
          <a:xfrm>
            <a:off x="8403494" y="2161849"/>
            <a:ext cx="518711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9D4B4CF0-3084-E4A2-210B-030E31C33A61}"/>
              </a:ext>
            </a:extLst>
          </p:cNvPr>
          <p:cNvSpPr txBox="1"/>
          <p:nvPr/>
        </p:nvSpPr>
        <p:spPr>
          <a:xfrm rot="16200000">
            <a:off x="8857915" y="182646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E19CE77-3469-9B5D-2845-DB4FCF3E02DB}"/>
              </a:ext>
            </a:extLst>
          </p:cNvPr>
          <p:cNvSpPr txBox="1"/>
          <p:nvPr/>
        </p:nvSpPr>
        <p:spPr>
          <a:xfrm rot="16200000">
            <a:off x="8189615" y="1435168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108E27E-9A77-F690-416D-41AD5C663A09}"/>
              </a:ext>
            </a:extLst>
          </p:cNvPr>
          <p:cNvSpPr txBox="1"/>
          <p:nvPr/>
        </p:nvSpPr>
        <p:spPr>
          <a:xfrm>
            <a:off x="7456468" y="2501521"/>
            <a:ext cx="1710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-   +   -      -   -   +   -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3507F228-3E5D-44C0-E5C9-FDC2CFC7EEDA}"/>
              </a:ext>
            </a:extLst>
          </p:cNvPr>
          <p:cNvCxnSpPr/>
          <p:nvPr/>
        </p:nvCxnSpPr>
        <p:spPr>
          <a:xfrm>
            <a:off x="6953652" y="4058851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5E5D32CB-2AB6-2EE1-9818-22388252D917}"/>
              </a:ext>
            </a:extLst>
          </p:cNvPr>
          <p:cNvCxnSpPr/>
          <p:nvPr/>
        </p:nvCxnSpPr>
        <p:spPr>
          <a:xfrm>
            <a:off x="6953653" y="3657973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70A3D903-6855-60B6-C006-0675C7E52A2A}"/>
              </a:ext>
            </a:extLst>
          </p:cNvPr>
          <p:cNvCxnSpPr/>
          <p:nvPr/>
        </p:nvCxnSpPr>
        <p:spPr>
          <a:xfrm>
            <a:off x="6953653" y="4474160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E35A70C4-12AA-C6D4-948D-A229192DA1BE}"/>
              </a:ext>
            </a:extLst>
          </p:cNvPr>
          <p:cNvCxnSpPr/>
          <p:nvPr/>
        </p:nvCxnSpPr>
        <p:spPr>
          <a:xfrm>
            <a:off x="6953653" y="4844042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AC07F0AA-63FF-6CE8-D7CE-D3FB3914DD0F}"/>
              </a:ext>
            </a:extLst>
          </p:cNvPr>
          <p:cNvSpPr txBox="1"/>
          <p:nvPr/>
        </p:nvSpPr>
        <p:spPr>
          <a:xfrm>
            <a:off x="6557310" y="350408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B456268-C55A-D87F-86A3-D4807E5DF25E}"/>
              </a:ext>
            </a:extLst>
          </p:cNvPr>
          <p:cNvSpPr txBox="1"/>
          <p:nvPr/>
        </p:nvSpPr>
        <p:spPr>
          <a:xfrm>
            <a:off x="6557310" y="390496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154E513-900F-36FB-FC3A-2D4A116110B5}"/>
              </a:ext>
            </a:extLst>
          </p:cNvPr>
          <p:cNvSpPr txBox="1"/>
          <p:nvPr/>
        </p:nvSpPr>
        <p:spPr>
          <a:xfrm>
            <a:off x="6537323" y="432027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74AE9D3-5865-784B-CF88-AB25FA06A242}"/>
              </a:ext>
            </a:extLst>
          </p:cNvPr>
          <p:cNvSpPr txBox="1"/>
          <p:nvPr/>
        </p:nvSpPr>
        <p:spPr>
          <a:xfrm>
            <a:off x="6553769" y="46901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5855F3E-0532-303E-DB06-243226BA5497}"/>
              </a:ext>
            </a:extLst>
          </p:cNvPr>
          <p:cNvSpPr txBox="1"/>
          <p:nvPr/>
        </p:nvSpPr>
        <p:spPr>
          <a:xfrm>
            <a:off x="6551504" y="510546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C08955DE-AE11-F8D3-E907-FE5CFB7879CB}"/>
              </a:ext>
            </a:extLst>
          </p:cNvPr>
          <p:cNvCxnSpPr/>
          <p:nvPr/>
        </p:nvCxnSpPr>
        <p:spPr>
          <a:xfrm>
            <a:off x="6966905" y="3200773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D331DC55-C5E9-0715-9EF8-AE3AEC5702F9}"/>
              </a:ext>
            </a:extLst>
          </p:cNvPr>
          <p:cNvSpPr txBox="1"/>
          <p:nvPr/>
        </p:nvSpPr>
        <p:spPr>
          <a:xfrm>
            <a:off x="6460941" y="304688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1E24F2DC-09D9-BC00-92CE-DAECBFAEEB8B}"/>
              </a:ext>
            </a:extLst>
          </p:cNvPr>
          <p:cNvCxnSpPr/>
          <p:nvPr/>
        </p:nvCxnSpPr>
        <p:spPr>
          <a:xfrm>
            <a:off x="2081032" y="3995637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4BC29450-036F-E408-1C05-EAA94138A8D1}"/>
              </a:ext>
            </a:extLst>
          </p:cNvPr>
          <p:cNvCxnSpPr/>
          <p:nvPr/>
        </p:nvCxnSpPr>
        <p:spPr>
          <a:xfrm>
            <a:off x="2081033" y="3601385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ED1D2BF3-98E7-E017-CDBD-6D2489A8661A}"/>
              </a:ext>
            </a:extLst>
          </p:cNvPr>
          <p:cNvCxnSpPr/>
          <p:nvPr/>
        </p:nvCxnSpPr>
        <p:spPr>
          <a:xfrm>
            <a:off x="2081033" y="4727820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B581A712-69AF-0794-E2D3-B584F613D35B}"/>
              </a:ext>
            </a:extLst>
          </p:cNvPr>
          <p:cNvSpPr txBox="1"/>
          <p:nvPr/>
        </p:nvSpPr>
        <p:spPr>
          <a:xfrm>
            <a:off x="1684690" y="344749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6C45A1F-40DE-83E3-38B1-20685E760C71}"/>
              </a:ext>
            </a:extLst>
          </p:cNvPr>
          <p:cNvSpPr txBox="1"/>
          <p:nvPr/>
        </p:nvSpPr>
        <p:spPr>
          <a:xfrm>
            <a:off x="1684690" y="384174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1852FA8-734A-4505-155C-1825AC40E73B}"/>
              </a:ext>
            </a:extLst>
          </p:cNvPr>
          <p:cNvSpPr txBox="1"/>
          <p:nvPr/>
        </p:nvSpPr>
        <p:spPr>
          <a:xfrm>
            <a:off x="1681149" y="457393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E47CF74-4100-6F22-40E1-2510CBBA333D}"/>
              </a:ext>
            </a:extLst>
          </p:cNvPr>
          <p:cNvSpPr txBox="1"/>
          <p:nvPr/>
        </p:nvSpPr>
        <p:spPr>
          <a:xfrm>
            <a:off x="1958789" y="517220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50CC7DAA-166E-D6FC-F541-ACE820A74B34}"/>
              </a:ext>
            </a:extLst>
          </p:cNvPr>
          <p:cNvCxnSpPr/>
          <p:nvPr/>
        </p:nvCxnSpPr>
        <p:spPr>
          <a:xfrm>
            <a:off x="2094285" y="3157437"/>
            <a:ext cx="2451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B26A19E1-944C-D378-74DF-8FDBE76A2042}"/>
              </a:ext>
            </a:extLst>
          </p:cNvPr>
          <p:cNvSpPr txBox="1"/>
          <p:nvPr/>
        </p:nvSpPr>
        <p:spPr>
          <a:xfrm>
            <a:off x="1588321" y="300354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4227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 Carvalho Schäfer</dc:creator>
  <cp:lastModifiedBy>Yasmin Carvalho Schäfer</cp:lastModifiedBy>
  <cp:revision>5</cp:revision>
  <dcterms:created xsi:type="dcterms:W3CDTF">2024-06-28T19:09:49Z</dcterms:created>
  <dcterms:modified xsi:type="dcterms:W3CDTF">2024-08-13T09:49:31Z</dcterms:modified>
</cp:coreProperties>
</file>